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38" autoAdjust="0"/>
    <p:restoredTop sz="94660"/>
  </p:normalViewPr>
  <p:slideViewPr>
    <p:cSldViewPr>
      <p:cViewPr>
        <p:scale>
          <a:sx n="70" d="100"/>
          <a:sy n="70" d="100"/>
        </p:scale>
        <p:origin x="-225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4B1D48-CFA6-4B64-A389-E73F13BBDEAE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38B9B0-3D8D-4264-B762-FA040915A72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82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 smtClean="0"/>
              <a:t>vWF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38B9B0-3D8D-4264-B762-FA040915A7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10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878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593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066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11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240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99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745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932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879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11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188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F0B90-C656-4125-B859-3F667D12B0FD}" type="datetimeFigureOut">
              <a:rPr lang="en-US" smtClean="0"/>
              <a:t>11/26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30DC36-E1D5-43EF-95B3-3CE7D124D0A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899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C:\Users\Ninel Azoitei\Desktop\125 5x des.tif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7570" y="1331880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C:\Users\Ninel Azoitei\Desktop\125 5x vWF.jpg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374" y="1331880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hteck 1"/>
          <p:cNvSpPr/>
          <p:nvPr/>
        </p:nvSpPr>
        <p:spPr>
          <a:xfrm>
            <a:off x="5652481" y="15751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1760503" y="2006478"/>
            <a:ext cx="288032" cy="21602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147" name="Picture 3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31" y="3554944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" name="Rechteck 5"/>
          <p:cNvSpPr/>
          <p:nvPr/>
        </p:nvSpPr>
        <p:spPr>
          <a:xfrm>
            <a:off x="1616487" y="3094808"/>
            <a:ext cx="288032" cy="21602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148" name="Picture 4"/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374" y="5780610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Rechteck 3"/>
          <p:cNvSpPr/>
          <p:nvPr/>
        </p:nvSpPr>
        <p:spPr>
          <a:xfrm>
            <a:off x="1635809" y="946542"/>
            <a:ext cx="6174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vWF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2078011" y="1960892"/>
            <a:ext cx="9284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637851" y="5427152"/>
            <a:ext cx="9284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883253" y="3070488"/>
            <a:ext cx="9669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637851" y="7585966"/>
            <a:ext cx="9669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4751194" y="955834"/>
            <a:ext cx="92525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smin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50" name="Picture 6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7570" y="3554944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6" name="Rechteck 15"/>
          <p:cNvSpPr/>
          <p:nvPr/>
        </p:nvSpPr>
        <p:spPr>
          <a:xfrm>
            <a:off x="5047587" y="2158878"/>
            <a:ext cx="288032" cy="21602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hteck 16"/>
          <p:cNvSpPr/>
          <p:nvPr/>
        </p:nvSpPr>
        <p:spPr>
          <a:xfrm>
            <a:off x="5365095" y="2113292"/>
            <a:ext cx="9284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330288" y="3072641"/>
            <a:ext cx="288032" cy="216024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152" name="Picture 8"/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7570" y="5780610"/>
            <a:ext cx="2880000" cy="21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1" name="Rechteck 20"/>
          <p:cNvSpPr/>
          <p:nvPr/>
        </p:nvSpPr>
        <p:spPr>
          <a:xfrm>
            <a:off x="3598431" y="5427152"/>
            <a:ext cx="9284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3598431" y="7585966"/>
            <a:ext cx="9669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606543" y="3070488"/>
            <a:ext cx="9669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tumora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 Verbindung 23"/>
          <p:cNvCxnSpPr/>
          <p:nvPr/>
        </p:nvCxnSpPr>
        <p:spPr>
          <a:xfrm>
            <a:off x="6099146" y="7796594"/>
            <a:ext cx="12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24"/>
          <p:cNvCxnSpPr/>
          <p:nvPr/>
        </p:nvCxnSpPr>
        <p:spPr>
          <a:xfrm>
            <a:off x="6099146" y="5580112"/>
            <a:ext cx="12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25"/>
          <p:cNvCxnSpPr/>
          <p:nvPr/>
        </p:nvCxnSpPr>
        <p:spPr>
          <a:xfrm>
            <a:off x="3212976" y="7796594"/>
            <a:ext cx="12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26"/>
          <p:cNvCxnSpPr/>
          <p:nvPr/>
        </p:nvCxnSpPr>
        <p:spPr>
          <a:xfrm>
            <a:off x="3212976" y="5580112"/>
            <a:ext cx="12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hteck 27"/>
          <p:cNvSpPr/>
          <p:nvPr/>
        </p:nvSpPr>
        <p:spPr>
          <a:xfrm>
            <a:off x="548680" y="570616"/>
            <a:ext cx="8435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xPC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346660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Bildschirmpräsentation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nel Azoitei</dc:creator>
  <cp:lastModifiedBy>Ninel Azoitei</cp:lastModifiedBy>
  <cp:revision>93</cp:revision>
  <dcterms:created xsi:type="dcterms:W3CDTF">2015-05-07T09:51:10Z</dcterms:created>
  <dcterms:modified xsi:type="dcterms:W3CDTF">2015-11-26T12:03:24Z</dcterms:modified>
</cp:coreProperties>
</file>